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08"/>
    <p:restoredTop sz="94679"/>
  </p:normalViewPr>
  <p:slideViewPr>
    <p:cSldViewPr snapToGrid="0" snapToObjects="1" showGuides="1">
      <p:cViewPr varScale="1">
        <p:scale>
          <a:sx n="61" d="100"/>
          <a:sy n="61" d="100"/>
        </p:scale>
        <p:origin x="2920" y="21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8064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/>
          </p:nvPr>
        </p:nvGraphicFramePr>
        <p:xfrm>
          <a:off x="2072604" y="3368386"/>
          <a:ext cx="2305506" cy="3633526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768502"/>
                <a:gridCol w="768502"/>
                <a:gridCol w="768502"/>
              </a:tblGrid>
              <a:tr h="216172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Sublineag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 dirty="0">
                          <a:effectLst/>
                        </a:rPr>
                        <a:t>Frequency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Percentag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</a:tr>
              <a:tr h="118546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2.2.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65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 smtClean="0">
                          <a:effectLst/>
                        </a:rPr>
                        <a:t>93.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</a:tr>
              <a:tr h="118546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2.2.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4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 smtClean="0">
                          <a:effectLst/>
                        </a:rPr>
                        <a:t>6.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702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 smtClean="0">
                          <a:effectLst/>
                        </a:rPr>
                        <a:t>100.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</a:tr>
              <a:tr h="118546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4.3.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 smtClean="0">
                          <a:effectLst/>
                        </a:rPr>
                        <a:t>1,54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 smtClean="0">
                          <a:effectLst/>
                        </a:rPr>
                        <a:t>41.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</a:tr>
              <a:tr h="118546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4.1.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91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 smtClean="0">
                          <a:effectLst/>
                        </a:rPr>
                        <a:t>24.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</a:tr>
              <a:tr h="118546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4.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42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 smtClean="0">
                          <a:effectLst/>
                        </a:rPr>
                        <a:t>11.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</a:tr>
              <a:tr h="118546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4.4.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18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 smtClean="0">
                          <a:effectLst/>
                        </a:rPr>
                        <a:t>4.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</a:tr>
              <a:tr h="118546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4.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14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 smtClean="0">
                          <a:effectLst/>
                        </a:rPr>
                        <a:t>3.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</a:tr>
              <a:tr h="118546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4.6.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11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 smtClean="0">
                          <a:effectLst/>
                        </a:rPr>
                        <a:t>3.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</a:tr>
              <a:tr h="118546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4.2.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1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 smtClean="0">
                          <a:effectLst/>
                        </a:rPr>
                        <a:t>3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</a:tr>
              <a:tr h="118546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4.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8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 smtClean="0">
                          <a:effectLst/>
                        </a:rPr>
                        <a:t>2.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</a:tr>
              <a:tr h="118546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4.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7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 smtClean="0">
                          <a:effectLst/>
                        </a:rPr>
                        <a:t>2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</a:tr>
              <a:tr h="118546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4.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3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 smtClean="0">
                          <a:effectLst/>
                        </a:rPr>
                        <a:t>1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</a:tr>
              <a:tr h="118546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3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 smtClean="0">
                          <a:effectLst/>
                        </a:rPr>
                        <a:t>0.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</a:tr>
              <a:tr h="118546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4.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3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 smtClean="0">
                          <a:effectLst/>
                        </a:rPr>
                        <a:t>0.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</a:tr>
              <a:tr h="118546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4.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 smtClean="0">
                          <a:effectLst/>
                        </a:rPr>
                        <a:t>0.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</a:tr>
              <a:tr h="118546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u="none" strike="noStrike">
                          <a:effectLst/>
                        </a:rPr>
                        <a:t>4.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>
                          <a:effectLst/>
                        </a:rPr>
                        <a:t>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 smtClean="0">
                          <a:effectLst/>
                        </a:rPr>
                        <a:t>0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 smtClean="0">
                          <a:effectLst/>
                        </a:rPr>
                        <a:t>3,706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200" u="none" strike="noStrike" dirty="0" smtClean="0">
                          <a:effectLst/>
                        </a:rPr>
                        <a:t>100.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973" marR="6973" marT="6973" marB="0" anchor="b"/>
                </a:tc>
              </a:tr>
            </a:tbl>
          </a:graphicData>
        </a:graphic>
      </p:graphicFrame>
      <p:sp>
        <p:nvSpPr>
          <p:cNvPr id="4" name="Content Placeholder 2"/>
          <p:cNvSpPr>
            <a:spLocks noGrp="1"/>
          </p:cNvSpPr>
          <p:nvPr>
            <p:ph idx="1"/>
          </p:nvPr>
        </p:nvSpPr>
        <p:spPr>
          <a:xfrm>
            <a:off x="1069383" y="1325105"/>
            <a:ext cx="5113487" cy="3267095"/>
          </a:xfrm>
        </p:spPr>
        <p:txBody>
          <a:bodyPr/>
          <a:lstStyle/>
          <a:p>
            <a:pPr marL="0" indent="0">
              <a:buNone/>
            </a:pPr>
            <a:r>
              <a:rPr lang="en-US" sz="1400" dirty="0" err="1" smtClean="0"/>
              <a:t>Sublineage</a:t>
            </a:r>
            <a:r>
              <a:rPr lang="en-US" sz="1400" dirty="0" smtClean="0"/>
              <a:t> frequency table; </a:t>
            </a:r>
            <a:r>
              <a:rPr lang="en-US" sz="1400" dirty="0"/>
              <a:t>n</a:t>
            </a:r>
            <a:r>
              <a:rPr lang="en-US" sz="1400" dirty="0" smtClean="0"/>
              <a:t>umbers </a:t>
            </a:r>
            <a:r>
              <a:rPr lang="en-US" sz="1400" dirty="0"/>
              <a:t>and percentage by  lineage assigned to each </a:t>
            </a:r>
            <a:r>
              <a:rPr lang="en-US" sz="1400" dirty="0" err="1"/>
              <a:t>sublineage</a:t>
            </a:r>
            <a:r>
              <a:rPr lang="en-US" sz="1400" dirty="0"/>
              <a:t>.</a:t>
            </a:r>
          </a:p>
          <a:p>
            <a:pPr marL="0" indent="0">
              <a:buNone/>
            </a:pPr>
            <a:endParaRPr lang="en-US" dirty="0" smtClean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465547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69</Words>
  <Application>Microsoft Macintosh PowerPoint</Application>
  <PresentationFormat>A4 Paper (210x297 mm)</PresentationFormat>
  <Paragraphs>5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ppong, Yaa</dc:creator>
  <cp:lastModifiedBy>Oppong, Yaa</cp:lastModifiedBy>
  <cp:revision>1</cp:revision>
  <dcterms:created xsi:type="dcterms:W3CDTF">2018-02-14T14:03:39Z</dcterms:created>
  <dcterms:modified xsi:type="dcterms:W3CDTF">2018-02-14T14:04:50Z</dcterms:modified>
</cp:coreProperties>
</file>